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64" r:id="rId3"/>
    <p:sldId id="262" r:id="rId4"/>
    <p:sldId id="260" r:id="rId5"/>
    <p:sldId id="263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816" y="6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B4B884-E663-4916-871C-3A2099C76691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F665BB-492B-481C-97FC-2F7AF1D4355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1706DF-2912-458B-8E51-46623A1EFC26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05636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7" Type="http://schemas.openxmlformats.org/officeDocument/2006/relationships/image" Target="../media/image13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/>
          <a:srcRect l="9496" t="9412" r="54281" b="64369"/>
          <a:stretch>
            <a:fillRect/>
          </a:stretch>
        </p:blipFill>
        <p:spPr bwMode="auto">
          <a:xfrm>
            <a:off x="3937813" y="1517076"/>
            <a:ext cx="786587" cy="540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 rot="3260477">
            <a:off x="4025870" y="1648697"/>
            <a:ext cx="5741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Antibiotics</a:t>
            </a:r>
            <a:endParaRPr lang="en-US" sz="700" dirty="0"/>
          </a:p>
        </p:txBody>
      </p:sp>
      <p:sp>
        <p:nvSpPr>
          <p:cNvPr id="5" name="TextBox 4"/>
          <p:cNvSpPr txBox="1"/>
          <p:nvPr/>
        </p:nvSpPr>
        <p:spPr>
          <a:xfrm>
            <a:off x="1828800" y="457200"/>
            <a:ext cx="1446230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ethodology 1</a:t>
            </a:r>
          </a:p>
          <a:p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613148" y="1905004"/>
            <a:ext cx="10162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tb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halleng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503759" y="2246824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acrific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33800" y="685800"/>
            <a:ext cx="17972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re-antibiotics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t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odel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2" cstate="print"/>
          <a:srcRect l="9496" t="9412" r="54485" b="63025"/>
          <a:stretch>
            <a:fillRect/>
          </a:stretch>
        </p:blipFill>
        <p:spPr bwMode="auto">
          <a:xfrm>
            <a:off x="2395967" y="1523364"/>
            <a:ext cx="782157" cy="56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 rot="3260477">
            <a:off x="2475464" y="1665792"/>
            <a:ext cx="5741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Antibiotics</a:t>
            </a:r>
            <a:endParaRPr lang="en-US" sz="700" dirty="0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3680068" y="2389912"/>
            <a:ext cx="56703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5545595" y="2389912"/>
            <a:ext cx="92788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473761" y="2389912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sted for  21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>
          <a:blip r:embed="rId2" cstate="print"/>
          <a:srcRect l="9496" t="9412" r="54359" b="61470"/>
          <a:stretch>
            <a:fillRect/>
          </a:stretch>
        </p:blipFill>
        <p:spPr bwMode="auto">
          <a:xfrm>
            <a:off x="3775186" y="3967545"/>
            <a:ext cx="796814" cy="6806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>
            <a:off x="2514600" y="4267203"/>
            <a:ext cx="118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t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halleng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V="1">
            <a:off x="3387925" y="4902577"/>
            <a:ext cx="54426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251434" y="4867645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sted for 21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503759" y="4757639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acrific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192214" y="3200400"/>
            <a:ext cx="18565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ost-antibiotics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t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odel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3260477">
            <a:off x="3864427" y="4145419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Antibiotics</a:t>
            </a:r>
            <a:endParaRPr lang="en-US" sz="800" dirty="0"/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5334282" y="4847575"/>
            <a:ext cx="109728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743200" y="1295400"/>
            <a:ext cx="3581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886200" y="1018401"/>
            <a:ext cx="1981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tibiotics treatment for 42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4191000" y="3886200"/>
            <a:ext cx="228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642270" y="3609201"/>
            <a:ext cx="20585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tibiotics treatment for 21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6324600" y="1219200"/>
            <a:ext cx="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2743200" y="1219200"/>
            <a:ext cx="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6479578" y="3808750"/>
            <a:ext cx="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4191000" y="3811250"/>
            <a:ext cx="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7910"/>
          <a:stretch>
            <a:fillRect/>
          </a:stretch>
        </p:blipFill>
        <p:spPr bwMode="auto">
          <a:xfrm>
            <a:off x="2971800" y="2057400"/>
            <a:ext cx="1047750" cy="718348"/>
          </a:xfrm>
          <a:prstGeom prst="rect">
            <a:avLst/>
          </a:prstGeom>
          <a:noFill/>
        </p:spPr>
      </p:pic>
      <p:pic>
        <p:nvPicPr>
          <p:cNvPr id="40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7910"/>
          <a:stretch>
            <a:fillRect/>
          </a:stretch>
        </p:blipFill>
        <p:spPr bwMode="auto">
          <a:xfrm>
            <a:off x="4466786" y="2001128"/>
            <a:ext cx="1047750" cy="718348"/>
          </a:xfrm>
          <a:prstGeom prst="rect">
            <a:avLst/>
          </a:prstGeom>
          <a:noFill/>
        </p:spPr>
      </p:pic>
      <p:pic>
        <p:nvPicPr>
          <p:cNvPr id="41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7910"/>
          <a:stretch>
            <a:fillRect/>
          </a:stretch>
        </p:blipFill>
        <p:spPr bwMode="auto">
          <a:xfrm>
            <a:off x="2286000" y="4572000"/>
            <a:ext cx="1047750" cy="718348"/>
          </a:xfrm>
          <a:prstGeom prst="rect">
            <a:avLst/>
          </a:prstGeom>
          <a:noFill/>
        </p:spPr>
      </p:pic>
      <p:pic>
        <p:nvPicPr>
          <p:cNvPr id="42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7910"/>
          <a:stretch>
            <a:fillRect/>
          </a:stretch>
        </p:blipFill>
        <p:spPr bwMode="auto">
          <a:xfrm>
            <a:off x="4286250" y="4572000"/>
            <a:ext cx="1047750" cy="718348"/>
          </a:xfrm>
          <a:prstGeom prst="rect">
            <a:avLst/>
          </a:prstGeom>
          <a:noFill/>
        </p:spPr>
      </p:pic>
      <p:sp>
        <p:nvSpPr>
          <p:cNvPr id="11" name="TextBox 10"/>
          <p:cNvSpPr txBox="1"/>
          <p:nvPr/>
        </p:nvSpPr>
        <p:spPr>
          <a:xfrm>
            <a:off x="3828630" y="2359113"/>
            <a:ext cx="6671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or 21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/>
          <p:cNvPicPr>
            <a:picLocks noChangeAspect="1" noChangeArrowheads="1"/>
          </p:cNvPicPr>
          <p:nvPr/>
        </p:nvPicPr>
        <p:blipFill>
          <a:blip r:embed="rId2" cstate="print"/>
          <a:srcRect l="9496" t="9412" r="26409" b="63211"/>
          <a:stretch>
            <a:fillRect/>
          </a:stretch>
        </p:blipFill>
        <p:spPr bwMode="auto">
          <a:xfrm>
            <a:off x="685800" y="789801"/>
            <a:ext cx="2057400" cy="8865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6" name="TextBox 45"/>
          <p:cNvSpPr txBox="1"/>
          <p:nvPr/>
        </p:nvSpPr>
        <p:spPr>
          <a:xfrm rot="3260477">
            <a:off x="936993" y="1049337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Antibiotics</a:t>
            </a:r>
            <a:endParaRPr lang="en-US" sz="800" dirty="0"/>
          </a:p>
        </p:txBody>
      </p:sp>
      <p:sp>
        <p:nvSpPr>
          <p:cNvPr id="10" name="TextBox 9"/>
          <p:cNvSpPr txBox="1"/>
          <p:nvPr/>
        </p:nvSpPr>
        <p:spPr>
          <a:xfrm>
            <a:off x="6503759" y="1905000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acrific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5288280" y="2057400"/>
            <a:ext cx="11887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105400" y="1274802"/>
            <a:ext cx="1167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ecal transplan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5772567" y="5229999"/>
            <a:ext cx="914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H="1">
            <a:off x="6653299" y="5153799"/>
            <a:ext cx="7620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H="1">
            <a:off x="6763167" y="5153799"/>
            <a:ext cx="7620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6757493" y="4676001"/>
            <a:ext cx="1167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ecal transplan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590736" y="5257465"/>
            <a:ext cx="1396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tibiotics for  12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653676" y="3304401"/>
            <a:ext cx="30508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ecal transplantation in post-antibiotics model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657600" y="1274802"/>
            <a:ext cx="12571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tb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halleng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2590800" y="2161401"/>
            <a:ext cx="8382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590800" y="1808202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or 21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431577" y="155180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5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6" name="Picture 2"/>
          <p:cNvPicPr>
            <a:picLocks noChangeAspect="1" noChangeArrowheads="1"/>
          </p:cNvPicPr>
          <p:nvPr/>
        </p:nvPicPr>
        <p:blipFill>
          <a:blip r:embed="rId2" cstate="print"/>
          <a:srcRect l="9496" t="9412" r="26409" b="62353"/>
          <a:stretch>
            <a:fillRect/>
          </a:stretch>
        </p:blipFill>
        <p:spPr bwMode="auto">
          <a:xfrm>
            <a:off x="3403693" y="4100732"/>
            <a:ext cx="2057400" cy="91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7" name="TextBox 56"/>
          <p:cNvSpPr txBox="1"/>
          <p:nvPr/>
        </p:nvSpPr>
        <p:spPr>
          <a:xfrm>
            <a:off x="1727293" y="4714672"/>
            <a:ext cx="118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t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halleng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8" name="Straight Arrow Connector 57"/>
          <p:cNvCxnSpPr/>
          <p:nvPr/>
        </p:nvCxnSpPr>
        <p:spPr>
          <a:xfrm flipV="1">
            <a:off x="2916015" y="5410200"/>
            <a:ext cx="79247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2794093" y="5105400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sted for 21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3260477">
            <a:off x="3676152" y="4389565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Antibiotics</a:t>
            </a:r>
            <a:endParaRPr lang="en-US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3429000" y="561201"/>
            <a:ext cx="29915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ecal transplantation in pre-antibiotics model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81000" y="76200"/>
            <a:ext cx="14462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ethodology 2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3" name="Straight Connector 62"/>
          <p:cNvCxnSpPr/>
          <p:nvPr/>
        </p:nvCxnSpPr>
        <p:spPr>
          <a:xfrm>
            <a:off x="3962400" y="4114800"/>
            <a:ext cx="381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5145662" y="3837801"/>
            <a:ext cx="1524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tibiotics treatmen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1066800" y="763250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7773650" y="4069830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3962400" y="4069830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46" name="AutoShape 2" descr="Image result for c57bl/6 mice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67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1940"/>
          <a:stretch>
            <a:fillRect/>
          </a:stretch>
        </p:blipFill>
        <p:spPr bwMode="auto">
          <a:xfrm>
            <a:off x="3477064" y="1623924"/>
            <a:ext cx="1123950" cy="718348"/>
          </a:xfrm>
          <a:prstGeom prst="rect">
            <a:avLst/>
          </a:prstGeom>
          <a:noFill/>
        </p:spPr>
      </p:pic>
      <p:pic>
        <p:nvPicPr>
          <p:cNvPr id="6148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7910"/>
          <a:stretch>
            <a:fillRect/>
          </a:stretch>
        </p:blipFill>
        <p:spPr bwMode="auto">
          <a:xfrm>
            <a:off x="1524000" y="1524000"/>
            <a:ext cx="1047750" cy="718348"/>
          </a:xfrm>
          <a:prstGeom prst="rect">
            <a:avLst/>
          </a:prstGeom>
          <a:noFill/>
        </p:spPr>
      </p:pic>
      <p:pic>
        <p:nvPicPr>
          <p:cNvPr id="68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1940"/>
          <a:stretch>
            <a:fillRect/>
          </a:stretch>
        </p:blipFill>
        <p:spPr bwMode="auto">
          <a:xfrm>
            <a:off x="1143000" y="4953000"/>
            <a:ext cx="1123950" cy="718348"/>
          </a:xfrm>
          <a:prstGeom prst="rect">
            <a:avLst/>
          </a:prstGeom>
          <a:noFill/>
        </p:spPr>
      </p:pic>
      <p:pic>
        <p:nvPicPr>
          <p:cNvPr id="69" name="Picture 4" descr="https://www.jax.org/~/media/JaxWeb/images/jax-mice-and-services/mice/datasheets/003831"/>
          <p:cNvPicPr>
            <a:picLocks noChangeAspect="1" noChangeArrowheads="1"/>
          </p:cNvPicPr>
          <p:nvPr/>
        </p:nvPicPr>
        <p:blipFill>
          <a:blip r:embed="rId3" cstate="print"/>
          <a:srcRect l="11940"/>
          <a:stretch>
            <a:fillRect/>
          </a:stretch>
        </p:blipFill>
        <p:spPr bwMode="auto">
          <a:xfrm>
            <a:off x="4114800" y="4953000"/>
            <a:ext cx="1123950" cy="718348"/>
          </a:xfrm>
          <a:prstGeom prst="rect">
            <a:avLst/>
          </a:prstGeom>
          <a:noFill/>
        </p:spPr>
      </p:pic>
      <p:cxnSp>
        <p:nvCxnSpPr>
          <p:cNvPr id="73" name="Straight Connector 72"/>
          <p:cNvCxnSpPr/>
          <p:nvPr/>
        </p:nvCxnSpPr>
        <p:spPr>
          <a:xfrm>
            <a:off x="5507512" y="2023404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5713836" y="2023404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5908440" y="2029264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6117112" y="2026916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6331644" y="2029264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6829860" y="5223804"/>
            <a:ext cx="11887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7049092" y="5189808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7255416" y="5189808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7450020" y="5195668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7658692" y="5193320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7873224" y="5195668"/>
            <a:ext cx="0" cy="76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8001000" y="5029200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acrifice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6" name="Straight Connector 85"/>
          <p:cNvCxnSpPr/>
          <p:nvPr/>
        </p:nvCxnSpPr>
        <p:spPr>
          <a:xfrm flipV="1">
            <a:off x="4775690" y="2033226"/>
            <a:ext cx="351986" cy="18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flipH="1">
            <a:off x="5130020" y="1953064"/>
            <a:ext cx="7620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 flipH="1">
            <a:off x="5212080" y="1981200"/>
            <a:ext cx="76200" cy="15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4165212" y="2077328"/>
            <a:ext cx="1396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tibiotics for  10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7086600" y="487680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5d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2514600" y="457200"/>
            <a:ext cx="8755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[Fig.S1]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8000" y="838200"/>
            <a:ext cx="2228850" cy="350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1752600" y="381000"/>
            <a:ext cx="4527516" cy="5436856"/>
            <a:chOff x="1752600" y="381000"/>
            <a:chExt cx="4527516" cy="5436856"/>
          </a:xfrm>
        </p:grpSpPr>
        <p:pic>
          <p:nvPicPr>
            <p:cNvPr id="65" name="Picture 3"/>
            <p:cNvPicPr>
              <a:picLocks noChangeAspect="1" noChangeArrowheads="1"/>
            </p:cNvPicPr>
            <p:nvPr/>
          </p:nvPicPr>
          <p:blipFill>
            <a:blip r:embed="rId3" cstate="print">
              <a:lum bright="22000" contrast="59000"/>
            </a:blip>
            <a:srcRect l="10717" t="23920" r="57293" b="38871"/>
            <a:stretch>
              <a:fillRect/>
            </a:stretch>
          </p:blipFill>
          <p:spPr bwMode="auto">
            <a:xfrm>
              <a:off x="3557150" y="1643673"/>
              <a:ext cx="2288720" cy="692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6" name="Picture 5"/>
            <p:cNvPicPr>
              <a:picLocks noChangeAspect="1" noChangeArrowheads="1"/>
            </p:cNvPicPr>
            <p:nvPr/>
          </p:nvPicPr>
          <p:blipFill>
            <a:blip r:embed="rId4" cstate="print">
              <a:lum contrast="29000"/>
            </a:blip>
            <a:srcRect l="7190" t="36573" r="47372" b="36828"/>
            <a:stretch>
              <a:fillRect/>
            </a:stretch>
          </p:blipFill>
          <p:spPr bwMode="auto">
            <a:xfrm>
              <a:off x="3557150" y="3225629"/>
              <a:ext cx="2294478" cy="6490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7" name="Picture 3"/>
            <p:cNvPicPr>
              <a:picLocks noChangeAspect="1" noChangeArrowheads="1"/>
            </p:cNvPicPr>
            <p:nvPr/>
          </p:nvPicPr>
          <p:blipFill>
            <a:blip r:embed="rId3" cstate="print">
              <a:lum bright="13000" contrast="36000"/>
            </a:blip>
            <a:srcRect l="44129" t="24602" r="27503" b="44186"/>
            <a:stretch>
              <a:fillRect/>
            </a:stretch>
          </p:blipFill>
          <p:spPr bwMode="auto">
            <a:xfrm>
              <a:off x="3822008" y="2546199"/>
              <a:ext cx="2029620" cy="5805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8" name="Picture 5"/>
            <p:cNvPicPr>
              <a:picLocks noChangeAspect="1" noChangeArrowheads="1"/>
            </p:cNvPicPr>
            <p:nvPr/>
          </p:nvPicPr>
          <p:blipFill>
            <a:blip r:embed="rId4" cstate="print">
              <a:lum contrast="9000"/>
            </a:blip>
            <a:srcRect l="55307" t="38599" r="5395" b="36828"/>
            <a:stretch>
              <a:fillRect/>
            </a:stretch>
          </p:blipFill>
          <p:spPr bwMode="auto">
            <a:xfrm>
              <a:off x="3912214" y="3967170"/>
              <a:ext cx="1984517" cy="5996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9" name="Picture 6"/>
            <p:cNvPicPr>
              <a:picLocks noChangeAspect="1" noChangeArrowheads="1"/>
            </p:cNvPicPr>
            <p:nvPr/>
          </p:nvPicPr>
          <p:blipFill>
            <a:blip r:embed="rId5" cstate="print">
              <a:lum bright="-8000" contrast="37000"/>
            </a:blip>
            <a:srcRect l="5028" t="53479" r="51077" b="15241"/>
            <a:stretch>
              <a:fillRect/>
            </a:stretch>
          </p:blipFill>
          <p:spPr bwMode="auto">
            <a:xfrm>
              <a:off x="3608010" y="4576882"/>
              <a:ext cx="2288721" cy="6204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0" name="Picture 7"/>
            <p:cNvPicPr>
              <a:picLocks noChangeAspect="1" noChangeArrowheads="1"/>
            </p:cNvPicPr>
            <p:nvPr/>
          </p:nvPicPr>
          <p:blipFill>
            <a:blip r:embed="rId6" cstate="print">
              <a:lum bright="12000" contrast="45000"/>
            </a:blip>
            <a:srcRect l="48430" t="54510" r="16341" b="15757"/>
            <a:stretch>
              <a:fillRect/>
            </a:stretch>
          </p:blipFill>
          <p:spPr bwMode="auto">
            <a:xfrm>
              <a:off x="3862313" y="5253777"/>
              <a:ext cx="2023862" cy="5640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0" name="TextBox 49"/>
            <p:cNvSpPr txBox="1"/>
            <p:nvPr/>
          </p:nvSpPr>
          <p:spPr>
            <a:xfrm rot="19008968">
              <a:off x="4005608" y="1221673"/>
              <a:ext cx="9412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Bifidobacterium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19008968">
              <a:off x="4185674" y="1178386"/>
              <a:ext cx="1085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Bacteroides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fragilis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 rot="19008968">
              <a:off x="4908063" y="1199469"/>
              <a:ext cx="8899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Campylobacter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 rot="19008968">
              <a:off x="3755063" y="1298449"/>
              <a:ext cx="7296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Bacteroides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 rot="19008968">
              <a:off x="4486390" y="1275547"/>
              <a:ext cx="6527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Prevotell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 rot="19008968">
              <a:off x="4694799" y="1263015"/>
              <a:ext cx="7360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Clostridium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rot="19008968">
              <a:off x="5319618" y="1245295"/>
              <a:ext cx="8066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Lactobacillus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 rot="19008968">
              <a:off x="5492721" y="1266825"/>
              <a:ext cx="7873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C. </a:t>
              </a:r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coccoides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9008968">
              <a:off x="5084063" y="1225018"/>
              <a:ext cx="9028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Ruminococcus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892512" y="1856601"/>
              <a:ext cx="765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Normal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048000" y="2694801"/>
              <a:ext cx="4411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>
                  <a:latin typeface="Times New Roman" pitchFamily="18" charset="0"/>
                  <a:cs typeface="Times New Roman" pitchFamily="18" charset="0"/>
                </a:rPr>
                <a:t>Mtb</a:t>
              </a:r>
              <a:endParaRPr 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474559" y="3352800"/>
              <a:ext cx="1106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Pre-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antbiotics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467632" y="4122314"/>
              <a:ext cx="14851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err="1" smtClean="0">
                  <a:latin typeface="Times New Roman" pitchFamily="18" charset="0"/>
                  <a:cs typeface="Times New Roman" pitchFamily="18" charset="0"/>
                </a:rPr>
                <a:t>Mtb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+pre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-antibiotics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752600" y="4676001"/>
              <a:ext cx="1981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>
                  <a:latin typeface="Times New Roman" pitchFamily="18" charset="0"/>
                  <a:cs typeface="Times New Roman" pitchFamily="18" charset="0"/>
                </a:rPr>
                <a:t>    </a:t>
              </a:r>
              <a:r>
                <a:rPr lang="en-US" sz="1200" b="1" i="1" dirty="0" err="1" smtClean="0">
                  <a:latin typeface="Times New Roman" pitchFamily="18" charset="0"/>
                  <a:cs typeface="Times New Roman" pitchFamily="18" charset="0"/>
                </a:rPr>
                <a:t>Mtb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+pre-antibiotics+FT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438400" y="5334000"/>
              <a:ext cx="1435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Pre-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antibiotics+FT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215606" y="381000"/>
              <a:ext cx="8643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Fig. S2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8938992">
              <a:off x="3403883" y="1127710"/>
              <a:ext cx="9701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Ladder (1kb)</a:t>
              </a:r>
              <a:endParaRPr lang="en-US" sz="12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13"/>
          <p:cNvGrpSpPr/>
          <p:nvPr/>
        </p:nvGrpSpPr>
        <p:grpSpPr>
          <a:xfrm>
            <a:off x="244588" y="4714129"/>
            <a:ext cx="8899412" cy="1686671"/>
            <a:chOff x="-288442" y="233080"/>
            <a:chExt cx="11094779" cy="2216238"/>
          </a:xfrm>
        </p:grpSpPr>
        <p:pic>
          <p:nvPicPr>
            <p:cNvPr id="15" name="Picture 2" descr="G:\Nargis 16.7.15\seq0030.jpg"/>
            <p:cNvPicPr>
              <a:picLocks noChangeAspect="1" noChangeArrowheads="1"/>
            </p:cNvPicPr>
            <p:nvPr/>
          </p:nvPicPr>
          <p:blipFill>
            <a:blip r:embed="rId2" cstate="print"/>
            <a:srcRect l="12500"/>
            <a:stretch>
              <a:fillRect/>
            </a:stretch>
          </p:blipFill>
          <p:spPr bwMode="auto">
            <a:xfrm>
              <a:off x="1825570" y="609599"/>
              <a:ext cx="2133601" cy="1828799"/>
            </a:xfrm>
            <a:prstGeom prst="rect">
              <a:avLst/>
            </a:prstGeom>
            <a:noFill/>
          </p:spPr>
        </p:pic>
        <p:pic>
          <p:nvPicPr>
            <p:cNvPr id="16" name="Picture 3" descr="G:\Nargis 16.7.15\seq0040.jpg"/>
            <p:cNvPicPr>
              <a:picLocks noChangeAspect="1" noChangeArrowheads="1"/>
            </p:cNvPicPr>
            <p:nvPr/>
          </p:nvPicPr>
          <p:blipFill>
            <a:blip r:embed="rId3" cstate="print"/>
            <a:srcRect l="12500"/>
            <a:stretch>
              <a:fillRect/>
            </a:stretch>
          </p:blipFill>
          <p:spPr bwMode="auto">
            <a:xfrm>
              <a:off x="6309746" y="609599"/>
              <a:ext cx="2133601" cy="1828799"/>
            </a:xfrm>
            <a:prstGeom prst="rect">
              <a:avLst/>
            </a:prstGeom>
            <a:noFill/>
          </p:spPr>
        </p:pic>
        <p:pic>
          <p:nvPicPr>
            <p:cNvPr id="17" name="Picture 4" descr="G:\Nargis 16.7.15\seq0024.jpg"/>
            <p:cNvPicPr>
              <a:picLocks noChangeAspect="1" noChangeArrowheads="1"/>
            </p:cNvPicPr>
            <p:nvPr/>
          </p:nvPicPr>
          <p:blipFill>
            <a:blip r:embed="rId4" cstate="print"/>
            <a:srcRect l="9375"/>
            <a:stretch>
              <a:fillRect/>
            </a:stretch>
          </p:blipFill>
          <p:spPr bwMode="auto">
            <a:xfrm rot="10800000">
              <a:off x="4031497" y="609599"/>
              <a:ext cx="2209800" cy="1828799"/>
            </a:xfrm>
            <a:prstGeom prst="rect">
              <a:avLst/>
            </a:prstGeom>
            <a:noFill/>
          </p:spPr>
        </p:pic>
        <p:sp>
          <p:nvSpPr>
            <p:cNvPr id="18" name="TextBox 17"/>
            <p:cNvSpPr txBox="1"/>
            <p:nvPr/>
          </p:nvSpPr>
          <p:spPr>
            <a:xfrm>
              <a:off x="2180267" y="233080"/>
              <a:ext cx="1596253" cy="3639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Post-antibiotic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647912" y="233080"/>
              <a:ext cx="1257301" cy="3709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Mtb</a:t>
              </a:r>
              <a:endParaRPr lang="en-US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488062" y="233081"/>
              <a:ext cx="2038334" cy="3639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 smtClean="0">
                  <a:latin typeface="Times New Roman" pitchFamily="18" charset="0"/>
                  <a:cs typeface="Times New Roman" pitchFamily="18" charset="0"/>
                </a:rPr>
                <a:t>Mtb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+post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-antibiotic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1" name="Picture 5" descr="G:\Nargis 16.7.15\seq0058.jpg"/>
            <p:cNvPicPr>
              <a:picLocks noChangeAspect="1" noChangeArrowheads="1"/>
            </p:cNvPicPr>
            <p:nvPr/>
          </p:nvPicPr>
          <p:blipFill>
            <a:blip r:embed="rId5" cstate="print"/>
            <a:srcRect l="12500" r="3646"/>
            <a:stretch>
              <a:fillRect/>
            </a:stretch>
          </p:blipFill>
          <p:spPr bwMode="auto">
            <a:xfrm>
              <a:off x="8535260" y="620519"/>
              <a:ext cx="2044700" cy="1828799"/>
            </a:xfrm>
            <a:prstGeom prst="rect">
              <a:avLst/>
            </a:prstGeom>
            <a:noFill/>
          </p:spPr>
        </p:pic>
        <p:sp>
          <p:nvSpPr>
            <p:cNvPr id="22" name="TextBox 21"/>
            <p:cNvSpPr txBox="1"/>
            <p:nvPr/>
          </p:nvSpPr>
          <p:spPr>
            <a:xfrm>
              <a:off x="8609742" y="249686"/>
              <a:ext cx="2196595" cy="3639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 smtClean="0">
                  <a:latin typeface="Times New Roman" pitchFamily="18" charset="0"/>
                  <a:cs typeface="Times New Roman" pitchFamily="18" charset="0"/>
                </a:rPr>
                <a:t>Mtb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+post-antibiotics+FT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3" name="Picture 3" descr="G:\Nargis 3.13.7.15\seq0014.jpg"/>
            <p:cNvPicPr>
              <a:picLocks noChangeAspect="1" noChangeArrowheads="1"/>
            </p:cNvPicPr>
            <p:nvPr/>
          </p:nvPicPr>
          <p:blipFill>
            <a:blip r:embed="rId6" cstate="print"/>
            <a:srcRect l="15517"/>
            <a:stretch>
              <a:fillRect/>
            </a:stretch>
          </p:blipFill>
          <p:spPr bwMode="auto">
            <a:xfrm>
              <a:off x="-288442" y="609598"/>
              <a:ext cx="2057401" cy="1826467"/>
            </a:xfrm>
            <a:prstGeom prst="rect">
              <a:avLst/>
            </a:prstGeom>
            <a:noFill/>
          </p:spPr>
        </p:pic>
        <p:sp>
          <p:nvSpPr>
            <p:cNvPr id="24" name="TextBox 23"/>
            <p:cNvSpPr txBox="1"/>
            <p:nvPr/>
          </p:nvSpPr>
          <p:spPr>
            <a:xfrm>
              <a:off x="263038" y="304894"/>
              <a:ext cx="1073204" cy="3709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Normal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70862" y="4343398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[B]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878861" y="15240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S3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035200" y="60960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[A]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352800" y="533400"/>
            <a:ext cx="2914650" cy="3790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F9D9197C5E49247BB3420E7F536A978" ma:contentTypeVersion="7" ma:contentTypeDescription="Create a new document." ma:contentTypeScope="" ma:versionID="4af6098475b9d2a52790565593fa18ee">
  <xsd:schema xmlns:xsd="http://www.w3.org/2001/XMLSchema" xmlns:p="http://schemas.microsoft.com/office/2006/metadata/properties" xmlns:ns2="1f2809b4-cdb6-4d27-85e1-333ec8200287" targetNamespace="http://schemas.microsoft.com/office/2006/metadata/properties" ma:root="true" ma:fieldsID="89577d04481b3a1fa4061352c44df483" ns2:_="">
    <xsd:import namespace="1f2809b4-cdb6-4d27-85e1-333ec820028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f2809b4-cdb6-4d27-85e1-333ec820028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1f2809b4-cdb6-4d27-85e1-333ec8200287">PPTX</FileFormat>
    <DocumentId xmlns="1f2809b4-cdb6-4d27-85e1-333ec8200287">Presentation 1.PPTX</DocumentId>
    <IsDeleted xmlns="1f2809b4-cdb6-4d27-85e1-333ec8200287">false</IsDeleted>
    <StageName xmlns="1f2809b4-cdb6-4d27-85e1-333ec8200287" xsi:nil="true"/>
    <Checked_x0020_Out_x0020_To xmlns="1f2809b4-cdb6-4d27-85e1-333ec8200287">
      <UserInfo>
        <DisplayName/>
        <AccountId xsi:nil="true"/>
        <AccountType/>
      </UserInfo>
    </Checked_x0020_Out_x0020_To>
    <TitleName xmlns="1f2809b4-cdb6-4d27-85e1-333ec8200287">Presentation 1.PPTX</TitleName>
    <DocumentType xmlns="1f2809b4-cdb6-4d27-85e1-333ec8200287">Presentation</DocumentType>
  </documentManagement>
</p:properties>
</file>

<file path=customXml/itemProps1.xml><?xml version="1.0" encoding="utf-8"?>
<ds:datastoreItem xmlns:ds="http://schemas.openxmlformats.org/officeDocument/2006/customXml" ds:itemID="{18342516-C243-44A7-8E9B-26BC77C7CD50}"/>
</file>

<file path=customXml/itemProps2.xml><?xml version="1.0" encoding="utf-8"?>
<ds:datastoreItem xmlns:ds="http://schemas.openxmlformats.org/officeDocument/2006/customXml" ds:itemID="{90AF61FD-00FA-4DE9-B802-77E81E395CBB}"/>
</file>

<file path=customXml/itemProps3.xml><?xml version="1.0" encoding="utf-8"?>
<ds:datastoreItem xmlns:ds="http://schemas.openxmlformats.org/officeDocument/2006/customXml" ds:itemID="{BB510500-4A0C-4C71-B11B-4B0B12CE90D0}"/>
</file>

<file path=docProps/app.xml><?xml version="1.0" encoding="utf-8"?>
<Properties xmlns="http://schemas.openxmlformats.org/officeDocument/2006/extended-properties" xmlns:vt="http://schemas.openxmlformats.org/officeDocument/2006/docPropsVTypes">
  <TotalTime>1074</TotalTime>
  <Words>117</Words>
  <Application>Microsoft Office PowerPoint</Application>
  <PresentationFormat>On-screen Show (4:3)</PresentationFormat>
  <Paragraphs>60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vedlab</dc:creator>
  <cp:lastModifiedBy>Nargis</cp:lastModifiedBy>
  <cp:revision>76</cp:revision>
  <dcterms:created xsi:type="dcterms:W3CDTF">2006-08-16T00:00:00Z</dcterms:created>
  <dcterms:modified xsi:type="dcterms:W3CDTF">2016-10-23T17:26:00Z</dcterms:modified>
</cp:coreProperties>
</file>